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91" r:id="rId2"/>
    <p:sldId id="299" r:id="rId3"/>
    <p:sldId id="256" r:id="rId4"/>
    <p:sldId id="277" r:id="rId5"/>
    <p:sldId id="273" r:id="rId6"/>
    <p:sldId id="257" r:id="rId7"/>
    <p:sldId id="278" r:id="rId8"/>
    <p:sldId id="274" r:id="rId9"/>
  </p:sldIdLst>
  <p:sldSz cx="9906000" cy="6858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y Kilburn" initials="LK" lastIdx="7" clrIdx="0">
    <p:extLst>
      <p:ext uri="{19B8F6BF-5375-455C-9EA6-DF929625EA0E}">
        <p15:presenceInfo xmlns:p15="http://schemas.microsoft.com/office/powerpoint/2012/main" userId="S-1-5-21-2720991719-3395378957-1752411362-3166" providerId="AD"/>
      </p:ext>
    </p:extLst>
  </p:cmAuthor>
  <p:cmAuthor id="2" name="Elena Lopez Knowles" initials="ELK" lastIdx="3" clrIdx="1">
    <p:extLst>
      <p:ext uri="{19B8F6BF-5375-455C-9EA6-DF929625EA0E}">
        <p15:presenceInfo xmlns:p15="http://schemas.microsoft.com/office/powerpoint/2012/main" userId="S-1-5-21-2720991719-3395378957-1752411362-7975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836" autoAdjust="0"/>
    <p:restoredTop sz="96265" autoAdjust="0"/>
  </p:normalViewPr>
  <p:slideViewPr>
    <p:cSldViewPr snapToGrid="0">
      <p:cViewPr varScale="1">
        <p:scale>
          <a:sx n="116" d="100"/>
          <a:sy n="116" d="100"/>
        </p:scale>
        <p:origin x="140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52" d="100"/>
        <a:sy n="15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commentAuthors" Target="commentAuthors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D9B2AB-EB6A-469B-AA0D-F10567EDBAEE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81075" y="1241425"/>
            <a:ext cx="48355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0363FA-22EB-48B4-87C5-E5A6D5A133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98250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0363FA-22EB-48B4-87C5-E5A6D5A13369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996076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939059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01266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3612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1006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0222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6198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4773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377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9872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61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8043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F8177-7207-4954-AA85-A6DAFE4E4114}" type="datetimeFigureOut">
              <a:rPr lang="en-GB" smtClean="0"/>
              <a:t>03/09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E50A5C-F987-4CF7-85EC-70507FBF9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625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03631" y="4122180"/>
            <a:ext cx="17475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534 Baseline samples</a:t>
            </a:r>
          </a:p>
        </p:txBody>
      </p:sp>
      <p:cxnSp>
        <p:nvCxnSpPr>
          <p:cNvPr id="10" name="Straight Connector 9"/>
          <p:cNvCxnSpPr>
            <a:cxnSpLocks/>
          </p:cNvCxnSpPr>
          <p:nvPr/>
        </p:nvCxnSpPr>
        <p:spPr>
          <a:xfrm flipH="1" flipV="1">
            <a:off x="2477428" y="4446697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808603" y="4706784"/>
            <a:ext cx="11011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nsufficient RNA for qPCR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90543" y="172478"/>
            <a:ext cx="3447803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Figure S1</a:t>
            </a:r>
            <a:r>
              <a:rPr lang="en-GB" sz="1200" b="1" dirty="0"/>
              <a:t>. </a:t>
            </a:r>
            <a:r>
              <a:rPr lang="en-US" sz="1200" dirty="0"/>
              <a:t>Consort diagram of patients from POETIC.</a:t>
            </a:r>
            <a:endParaRPr lang="en-GB" sz="12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720055" y="5225292"/>
            <a:ext cx="13227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R/</a:t>
            </a:r>
            <a:r>
              <a:rPr lang="en-US" sz="1400" dirty="0" err="1"/>
              <a:t>PgR</a:t>
            </a:r>
            <a:r>
              <a:rPr lang="en-US" sz="1400" dirty="0"/>
              <a:t> IHC 534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616984" y="5852219"/>
            <a:ext cx="15289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R/</a:t>
            </a:r>
            <a:r>
              <a:rPr lang="en-US" sz="1400" dirty="0" err="1"/>
              <a:t>PgR</a:t>
            </a:r>
            <a:r>
              <a:rPr lang="en-US" sz="1400" dirty="0"/>
              <a:t> scores 515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197565" y="5225292"/>
            <a:ext cx="11464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R qPCR 389 </a:t>
            </a:r>
            <a:endParaRPr lang="en-GB" sz="1400" dirty="0"/>
          </a:p>
        </p:txBody>
      </p:sp>
      <p:cxnSp>
        <p:nvCxnSpPr>
          <p:cNvPr id="40" name="Straight Connector 39"/>
          <p:cNvCxnSpPr/>
          <p:nvPr/>
        </p:nvCxnSpPr>
        <p:spPr>
          <a:xfrm>
            <a:off x="1373364" y="4669584"/>
            <a:ext cx="2381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6427964" y="3741803"/>
            <a:ext cx="17876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188 Baseline samples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3178326" y="5852219"/>
            <a:ext cx="11849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R mRNA 367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8595084" y="4645537"/>
            <a:ext cx="106365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Insufficient RNA for qPCR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481080" y="5188967"/>
            <a:ext cx="13227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R/</a:t>
            </a:r>
            <a:r>
              <a:rPr lang="en-US" sz="1400" dirty="0" err="1"/>
              <a:t>PgR</a:t>
            </a:r>
            <a:r>
              <a:rPr lang="en-US" sz="1400" dirty="0"/>
              <a:t> IHC 188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402373" y="5815894"/>
            <a:ext cx="15289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R/</a:t>
            </a:r>
            <a:r>
              <a:rPr lang="en-US" sz="1400" dirty="0" err="1"/>
              <a:t>PgR</a:t>
            </a:r>
            <a:r>
              <a:rPr lang="en-US" sz="1400" dirty="0"/>
              <a:t> scores 186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7950495" y="5188967"/>
            <a:ext cx="11464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R qPCR 184 </a:t>
            </a:r>
            <a:endParaRPr lang="en-GB" sz="1400" dirty="0"/>
          </a:p>
        </p:txBody>
      </p:sp>
      <p:sp>
        <p:nvSpPr>
          <p:cNvPr id="62" name="TextBox 61"/>
          <p:cNvSpPr txBox="1"/>
          <p:nvPr/>
        </p:nvSpPr>
        <p:spPr>
          <a:xfrm>
            <a:off x="7931258" y="5815894"/>
            <a:ext cx="11849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ER mRNA 171</a:t>
            </a:r>
          </a:p>
        </p:txBody>
      </p:sp>
      <p:cxnSp>
        <p:nvCxnSpPr>
          <p:cNvPr id="63" name="Straight Connector 62"/>
          <p:cNvCxnSpPr>
            <a:stCxn id="28" idx="2"/>
            <a:endCxn id="30" idx="0"/>
          </p:cNvCxnSpPr>
          <p:nvPr/>
        </p:nvCxnSpPr>
        <p:spPr>
          <a:xfrm>
            <a:off x="1381455" y="5533069"/>
            <a:ext cx="2" cy="3191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3761967" y="5496744"/>
            <a:ext cx="0" cy="3554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6206375" y="5460419"/>
            <a:ext cx="0" cy="3554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8575268" y="5496744"/>
            <a:ext cx="0" cy="35547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>
            <a:off x="1734672" y="1238735"/>
            <a:ext cx="14879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2607 HER2- Cases</a:t>
            </a:r>
          </a:p>
        </p:txBody>
      </p:sp>
      <p:sp>
        <p:nvSpPr>
          <p:cNvPr id="69" name="TextBox 68"/>
          <p:cNvSpPr txBox="1"/>
          <p:nvPr/>
        </p:nvSpPr>
        <p:spPr>
          <a:xfrm>
            <a:off x="6596263" y="1213667"/>
            <a:ext cx="14318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317 HER2+ Cases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3559480" y="414951"/>
            <a:ext cx="3233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2976 POETIC AI-treatment Group Patients</a:t>
            </a:r>
          </a:p>
        </p:txBody>
      </p:sp>
      <p:cxnSp>
        <p:nvCxnSpPr>
          <p:cNvPr id="71" name="Straight Connector 70"/>
          <p:cNvCxnSpPr/>
          <p:nvPr/>
        </p:nvCxnSpPr>
        <p:spPr>
          <a:xfrm flipH="1" flipV="1">
            <a:off x="2477428" y="816071"/>
            <a:ext cx="2010" cy="39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/>
          <p:cNvCxnSpPr/>
          <p:nvPr/>
        </p:nvCxnSpPr>
        <p:spPr>
          <a:xfrm flipH="1" flipV="1">
            <a:off x="7308434" y="816071"/>
            <a:ext cx="2010" cy="39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Straight Connector 72"/>
          <p:cNvCxnSpPr/>
          <p:nvPr/>
        </p:nvCxnSpPr>
        <p:spPr>
          <a:xfrm>
            <a:off x="2477428" y="812746"/>
            <a:ext cx="4831006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Straight Connector 73"/>
          <p:cNvCxnSpPr/>
          <p:nvPr/>
        </p:nvCxnSpPr>
        <p:spPr>
          <a:xfrm flipH="1" flipV="1">
            <a:off x="5039653" y="698446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Straight Connector 74"/>
          <p:cNvCxnSpPr/>
          <p:nvPr/>
        </p:nvCxnSpPr>
        <p:spPr>
          <a:xfrm flipV="1">
            <a:off x="2499208" y="3233831"/>
            <a:ext cx="0" cy="83620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/>
          <p:cNvCxnSpPr/>
          <p:nvPr/>
        </p:nvCxnSpPr>
        <p:spPr>
          <a:xfrm flipV="1">
            <a:off x="1373363" y="4670159"/>
            <a:ext cx="0" cy="47643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Connector 77"/>
          <p:cNvCxnSpPr/>
          <p:nvPr/>
        </p:nvCxnSpPr>
        <p:spPr>
          <a:xfrm flipV="1">
            <a:off x="3759697" y="4668621"/>
            <a:ext cx="0" cy="47643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 flipH="1" flipV="1">
            <a:off x="7308434" y="1638245"/>
            <a:ext cx="0" cy="19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0" name="Straight Connector 79"/>
          <p:cNvCxnSpPr/>
          <p:nvPr/>
        </p:nvCxnSpPr>
        <p:spPr>
          <a:xfrm flipV="1">
            <a:off x="7329511" y="4177068"/>
            <a:ext cx="0" cy="47643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Straight Connector 80"/>
          <p:cNvCxnSpPr/>
          <p:nvPr/>
        </p:nvCxnSpPr>
        <p:spPr>
          <a:xfrm>
            <a:off x="6203667" y="4659205"/>
            <a:ext cx="23812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 flipV="1">
            <a:off x="6203666" y="4659780"/>
            <a:ext cx="0" cy="47643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Straight Connector 82"/>
          <p:cNvCxnSpPr/>
          <p:nvPr/>
        </p:nvCxnSpPr>
        <p:spPr>
          <a:xfrm flipV="1">
            <a:off x="8590000" y="4658242"/>
            <a:ext cx="0" cy="476436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192750" y="5544285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Inadequate IHC</a:t>
            </a:r>
            <a:endParaRPr lang="en-GB" sz="1000" dirty="0"/>
          </a:p>
        </p:txBody>
      </p:sp>
      <p:sp>
        <p:nvSpPr>
          <p:cNvPr id="43" name="TextBox 42"/>
          <p:cNvSpPr txBox="1"/>
          <p:nvPr/>
        </p:nvSpPr>
        <p:spPr>
          <a:xfrm>
            <a:off x="3808279" y="5535485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ailed QC</a:t>
            </a:r>
            <a:endParaRPr lang="en-GB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5100934" y="5536033"/>
            <a:ext cx="9893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Inadequate IHC</a:t>
            </a:r>
            <a:endParaRPr lang="en-GB" sz="1000" dirty="0"/>
          </a:p>
        </p:txBody>
      </p:sp>
      <p:sp>
        <p:nvSpPr>
          <p:cNvPr id="45" name="TextBox 44"/>
          <p:cNvSpPr txBox="1"/>
          <p:nvPr/>
        </p:nvSpPr>
        <p:spPr>
          <a:xfrm>
            <a:off x="8595084" y="5535484"/>
            <a:ext cx="678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ailed QC</a:t>
            </a:r>
            <a:endParaRPr lang="en-GB" sz="1000" dirty="0"/>
          </a:p>
        </p:txBody>
      </p:sp>
      <p:sp>
        <p:nvSpPr>
          <p:cNvPr id="6" name="TextBox 5"/>
          <p:cNvSpPr txBox="1"/>
          <p:nvPr/>
        </p:nvSpPr>
        <p:spPr>
          <a:xfrm>
            <a:off x="7499732" y="2039885"/>
            <a:ext cx="2455288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38 Ki67 Baseline &lt;10%</a:t>
            </a:r>
          </a:p>
          <a:p>
            <a:r>
              <a:rPr lang="en-GB" sz="1400" dirty="0"/>
              <a:t>20 No Block</a:t>
            </a:r>
          </a:p>
          <a:p>
            <a:r>
              <a:rPr lang="en-GB" sz="1400" dirty="0"/>
              <a:t>15 No Invasive Tumour in Block</a:t>
            </a:r>
          </a:p>
          <a:p>
            <a:r>
              <a:rPr lang="en-GB" sz="1400" dirty="0"/>
              <a:t>20 No Ki67 Baseline</a:t>
            </a:r>
          </a:p>
          <a:p>
            <a:r>
              <a:rPr lang="en-GB" sz="1400" dirty="0"/>
              <a:t>36 No RNA availabl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673452" y="3316795"/>
            <a:ext cx="2363917" cy="7386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69 No Block</a:t>
            </a:r>
          </a:p>
          <a:p>
            <a:r>
              <a:rPr lang="en-GB" sz="1400" dirty="0"/>
              <a:t>6 No Invasive Tumour in Block</a:t>
            </a:r>
          </a:p>
          <a:p>
            <a:r>
              <a:rPr lang="en-GB" sz="1400" dirty="0"/>
              <a:t>1 No Ki67</a:t>
            </a:r>
          </a:p>
        </p:txBody>
      </p:sp>
      <p:cxnSp>
        <p:nvCxnSpPr>
          <p:cNvPr id="53" name="Straight Connector 52"/>
          <p:cNvCxnSpPr/>
          <p:nvPr/>
        </p:nvCxnSpPr>
        <p:spPr>
          <a:xfrm flipH="1" flipV="1">
            <a:off x="2499208" y="1569957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TextBox 2"/>
          <p:cNvSpPr txBox="1"/>
          <p:nvPr/>
        </p:nvSpPr>
        <p:spPr>
          <a:xfrm>
            <a:off x="4000378" y="848819"/>
            <a:ext cx="2030503" cy="32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GB" sz="1400" dirty="0"/>
              <a:t>52 HER2 status unknown</a:t>
            </a:r>
          </a:p>
          <a:p>
            <a:endParaRPr lang="en-GB" sz="1400" dirty="0"/>
          </a:p>
        </p:txBody>
      </p:sp>
      <p:sp>
        <p:nvSpPr>
          <p:cNvPr id="47" name="TextBox 46"/>
          <p:cNvSpPr txBox="1"/>
          <p:nvPr/>
        </p:nvSpPr>
        <p:spPr>
          <a:xfrm>
            <a:off x="829065" y="6442821"/>
            <a:ext cx="11047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IHC only 148</a:t>
            </a:r>
          </a:p>
        </p:txBody>
      </p:sp>
      <p:cxnSp>
        <p:nvCxnSpPr>
          <p:cNvPr id="48" name="Straight Connector 47"/>
          <p:cNvCxnSpPr>
            <a:endCxn id="47" idx="0"/>
          </p:cNvCxnSpPr>
          <p:nvPr/>
        </p:nvCxnSpPr>
        <p:spPr>
          <a:xfrm>
            <a:off x="1381455" y="6123671"/>
            <a:ext cx="6" cy="3191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3241394" y="6442821"/>
            <a:ext cx="1128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mRNA only 0</a:t>
            </a:r>
          </a:p>
        </p:txBody>
      </p:sp>
      <p:cxnSp>
        <p:nvCxnSpPr>
          <p:cNvPr id="50" name="Straight Connector 49"/>
          <p:cNvCxnSpPr>
            <a:endCxn id="49" idx="0"/>
          </p:cNvCxnSpPr>
          <p:nvPr/>
        </p:nvCxnSpPr>
        <p:spPr>
          <a:xfrm>
            <a:off x="3805807" y="6123671"/>
            <a:ext cx="5" cy="3191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1957589" y="6208852"/>
            <a:ext cx="14141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IHC &amp; mRNA 367</a:t>
            </a:r>
          </a:p>
        </p:txBody>
      </p:sp>
      <p:cxnSp>
        <p:nvCxnSpPr>
          <p:cNvPr id="5" name="Straight Connector 4"/>
          <p:cNvCxnSpPr/>
          <p:nvPr/>
        </p:nvCxnSpPr>
        <p:spPr>
          <a:xfrm>
            <a:off x="1859543" y="6123671"/>
            <a:ext cx="286386" cy="8518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H="1">
            <a:off x="3093766" y="6121523"/>
            <a:ext cx="286386" cy="8518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5702186" y="6453552"/>
            <a:ext cx="1013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IHC only 15</a:t>
            </a:r>
          </a:p>
        </p:txBody>
      </p:sp>
      <p:cxnSp>
        <p:nvCxnSpPr>
          <p:cNvPr id="58" name="Straight Connector 57"/>
          <p:cNvCxnSpPr>
            <a:endCxn id="57" idx="0"/>
          </p:cNvCxnSpPr>
          <p:nvPr/>
        </p:nvCxnSpPr>
        <p:spPr>
          <a:xfrm>
            <a:off x="6208891" y="6134402"/>
            <a:ext cx="4" cy="3191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8068830" y="6453552"/>
            <a:ext cx="11288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mRNA only 0</a:t>
            </a:r>
          </a:p>
        </p:txBody>
      </p:sp>
      <p:cxnSp>
        <p:nvCxnSpPr>
          <p:cNvPr id="76" name="Straight Connector 75"/>
          <p:cNvCxnSpPr>
            <a:endCxn id="67" idx="0"/>
          </p:cNvCxnSpPr>
          <p:nvPr/>
        </p:nvCxnSpPr>
        <p:spPr>
          <a:xfrm>
            <a:off x="8633243" y="6134402"/>
            <a:ext cx="5" cy="31915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6785026" y="6219583"/>
            <a:ext cx="14141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IHC &amp; mRNA 171</a:t>
            </a:r>
          </a:p>
        </p:txBody>
      </p:sp>
      <p:cxnSp>
        <p:nvCxnSpPr>
          <p:cNvPr id="85" name="Straight Connector 84"/>
          <p:cNvCxnSpPr/>
          <p:nvPr/>
        </p:nvCxnSpPr>
        <p:spPr>
          <a:xfrm>
            <a:off x="6686979" y="6134402"/>
            <a:ext cx="286386" cy="8518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/>
          <p:cNvCxnSpPr/>
          <p:nvPr/>
        </p:nvCxnSpPr>
        <p:spPr>
          <a:xfrm flipH="1">
            <a:off x="7921202" y="6132254"/>
            <a:ext cx="286386" cy="85181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81E8CF36-C813-48CE-A727-D5EC55266DF3}"/>
              </a:ext>
            </a:extLst>
          </p:cNvPr>
          <p:cNvSpPr txBox="1"/>
          <p:nvPr/>
        </p:nvSpPr>
        <p:spPr>
          <a:xfrm>
            <a:off x="840673" y="1829191"/>
            <a:ext cx="464040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Case selection based on:</a:t>
            </a:r>
          </a:p>
          <a:p>
            <a:pPr marL="285750" indent="-285750">
              <a:buFontTx/>
              <a:buChar char="-"/>
            </a:pPr>
            <a:r>
              <a:rPr lang="en-GB" sz="1400" dirty="0"/>
              <a:t>Baseline Ki67% &gt;10% and</a:t>
            </a:r>
          </a:p>
          <a:p>
            <a:pPr marL="285750" indent="-285750">
              <a:buFontTx/>
              <a:buChar char="-"/>
            </a:pPr>
            <a:r>
              <a:rPr lang="en-GB" sz="1400" dirty="0"/>
              <a:t>Ki67 response categories:</a:t>
            </a:r>
          </a:p>
          <a:p>
            <a:r>
              <a:rPr lang="en-GB" sz="1400" dirty="0"/>
              <a:t>	15% worst responders: PR (n=230)</a:t>
            </a:r>
          </a:p>
          <a:p>
            <a:r>
              <a:rPr lang="en-GB" sz="1400" dirty="0"/>
              <a:t>	30% of the 50% best responders: GR (n=230)</a:t>
            </a:r>
          </a:p>
          <a:p>
            <a:r>
              <a:rPr lang="en-GB" sz="1400" dirty="0"/>
              <a:t>	30% of the 35% intermediate responders: IR (n=150)</a:t>
            </a:r>
          </a:p>
        </p:txBody>
      </p:sp>
    </p:spTree>
    <p:extLst>
      <p:ext uri="{BB962C8B-B14F-4D97-AF65-F5344CB8AC3E}">
        <p14:creationId xmlns:p14="http://schemas.microsoft.com/office/powerpoint/2010/main" val="8318247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59123" y="143474"/>
            <a:ext cx="5167505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Table S1</a:t>
            </a:r>
            <a:r>
              <a:rPr lang="en-GB" sz="1200" b="1" dirty="0"/>
              <a:t>. </a:t>
            </a:r>
            <a:r>
              <a:rPr lang="en-US" sz="1200" dirty="0" err="1"/>
              <a:t>Clinicopathological</a:t>
            </a:r>
            <a:r>
              <a:rPr lang="en-US" sz="1200" dirty="0"/>
              <a:t> characteristics of the population by IHC categories.</a:t>
            </a:r>
            <a:endParaRPr lang="en-GB" sz="1200" dirty="0"/>
          </a:p>
          <a:p>
            <a:endParaRPr lang="en-GB" sz="1200" b="1" dirty="0"/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20771265-279E-4C6F-A432-B68DF430A03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3823179"/>
              </p:ext>
            </p:extLst>
          </p:nvPr>
        </p:nvGraphicFramePr>
        <p:xfrm>
          <a:off x="396909" y="591138"/>
          <a:ext cx="7669853" cy="6234003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73125">
                  <a:extLst>
                    <a:ext uri="{9D8B030D-6E8A-4147-A177-3AD203B41FA5}">
                      <a16:colId xmlns:a16="http://schemas.microsoft.com/office/drawing/2014/main" xmlns="" val="264897116"/>
                    </a:ext>
                  </a:extLst>
                </a:gridCol>
                <a:gridCol w="635204">
                  <a:extLst>
                    <a:ext uri="{9D8B030D-6E8A-4147-A177-3AD203B41FA5}">
                      <a16:colId xmlns:a16="http://schemas.microsoft.com/office/drawing/2014/main" xmlns="" val="1026443898"/>
                    </a:ext>
                  </a:extLst>
                </a:gridCol>
                <a:gridCol w="948066">
                  <a:extLst>
                    <a:ext uri="{9D8B030D-6E8A-4147-A177-3AD203B41FA5}">
                      <a16:colId xmlns:a16="http://schemas.microsoft.com/office/drawing/2014/main" xmlns="" val="2980743892"/>
                    </a:ext>
                  </a:extLst>
                </a:gridCol>
                <a:gridCol w="771094">
                  <a:extLst>
                    <a:ext uri="{9D8B030D-6E8A-4147-A177-3AD203B41FA5}">
                      <a16:colId xmlns:a16="http://schemas.microsoft.com/office/drawing/2014/main" xmlns="" val="3548756950"/>
                    </a:ext>
                  </a:extLst>
                </a:gridCol>
                <a:gridCol w="568840">
                  <a:extLst>
                    <a:ext uri="{9D8B030D-6E8A-4147-A177-3AD203B41FA5}">
                      <a16:colId xmlns:a16="http://schemas.microsoft.com/office/drawing/2014/main" xmlns="" val="3273548468"/>
                    </a:ext>
                  </a:extLst>
                </a:gridCol>
                <a:gridCol w="948066">
                  <a:extLst>
                    <a:ext uri="{9D8B030D-6E8A-4147-A177-3AD203B41FA5}">
                      <a16:colId xmlns:a16="http://schemas.microsoft.com/office/drawing/2014/main" xmlns="" val="252586216"/>
                    </a:ext>
                  </a:extLst>
                </a:gridCol>
                <a:gridCol w="771094">
                  <a:extLst>
                    <a:ext uri="{9D8B030D-6E8A-4147-A177-3AD203B41FA5}">
                      <a16:colId xmlns:a16="http://schemas.microsoft.com/office/drawing/2014/main" xmlns="" val="3681813513"/>
                    </a:ext>
                  </a:extLst>
                </a:gridCol>
                <a:gridCol w="635204">
                  <a:extLst>
                    <a:ext uri="{9D8B030D-6E8A-4147-A177-3AD203B41FA5}">
                      <a16:colId xmlns:a16="http://schemas.microsoft.com/office/drawing/2014/main" xmlns="" val="3574674411"/>
                    </a:ext>
                  </a:extLst>
                </a:gridCol>
                <a:gridCol w="948066">
                  <a:extLst>
                    <a:ext uri="{9D8B030D-6E8A-4147-A177-3AD203B41FA5}">
                      <a16:colId xmlns:a16="http://schemas.microsoft.com/office/drawing/2014/main" xmlns="" val="2548233180"/>
                    </a:ext>
                  </a:extLst>
                </a:gridCol>
                <a:gridCol w="771094">
                  <a:extLst>
                    <a:ext uri="{9D8B030D-6E8A-4147-A177-3AD203B41FA5}">
                      <a16:colId xmlns:a16="http://schemas.microsoft.com/office/drawing/2014/main" xmlns="" val="72851054"/>
                    </a:ext>
                  </a:extLst>
                </a:gridCol>
              </a:tblGrid>
              <a:tr h="149492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>
                          <a:effectLst/>
                        </a:rPr>
                        <a:t>HER2 status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HER2- (n=515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HER2+ (n=186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TOTAL (n=701)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996571777"/>
                  </a:ext>
                </a:extLst>
              </a:tr>
              <a:tr h="254323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>
                          <a:effectLst/>
                        </a:rPr>
                        <a:t>ER IHC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&lt;1% (n=27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u="none" strike="noStrike">
                          <a:effectLst/>
                        </a:rPr>
                        <a:t>≥1 to 10% (n=18)</a:t>
                      </a:r>
                      <a:endParaRPr lang="pt-BR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≥10% (n=470)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&lt;1% (n=5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u="none" strike="noStrike">
                          <a:effectLst/>
                        </a:rPr>
                        <a:t>≥1 to 10% (n=17)</a:t>
                      </a:r>
                      <a:endParaRPr lang="pt-BR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≥10% (n=164)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&lt;1% (n=32)</a:t>
                      </a:r>
                      <a:endParaRPr lang="en-GB" sz="9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pt-BR" sz="900" u="none" strike="noStrike">
                          <a:effectLst/>
                        </a:rPr>
                        <a:t>≥1 to 10% (n=35)</a:t>
                      </a:r>
                      <a:endParaRPr lang="pt-BR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900" u="none" strike="noStrike">
                          <a:effectLst/>
                        </a:rPr>
                        <a:t>≥10% (n=634)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ctr"/>
                </a:tc>
                <a:extLst>
                  <a:ext uri="{0D108BD9-81ED-4DB2-BD59-A6C34878D82A}">
                    <a16:rowId xmlns:a16="http://schemas.microsoft.com/office/drawing/2014/main" xmlns="" val="748693847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Age (years)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64657430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Media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9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8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4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7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6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3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8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7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934893043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&lt;59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 (4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1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8 (1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2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1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9 (1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 (3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 (1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7 (1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7801957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60-69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 (2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 (3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9 (3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6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 (4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6 (4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 (3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3 (3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45 (3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522998292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70-79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1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2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48 (3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2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 (3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5 (2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 (1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 (3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93 (3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2334133644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≥80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1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2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5 (1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4 (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1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1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9 (1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402089870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umor Size (cm)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696895049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Media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4041736111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≤2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9 (7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 (5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05 (6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4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 (5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3 (6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1 (6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8 (5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18 (6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4109044414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&gt;2 &amp; ≤5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 (3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 (5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58 (3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6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 (4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6 (2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 (3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7 (4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04 (3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386146113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&gt;5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 (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2454532104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Unknow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989702928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umor Grade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290869997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1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9 (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3 (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822216443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2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1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 (4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70 (5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4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2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9 (4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 (1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 (3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49 (5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4221633889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3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1 (7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 (3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8 (2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4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 (7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6 (4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3 (7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9 (5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84 (2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2890485417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Unknow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1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3 (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2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5 (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8 (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092680798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Nodal Status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626103444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3 (4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 (5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74 (5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8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0 (5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0 (5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7 (5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9 (5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64 (5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49086228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&gt;1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4 (5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 (5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96 (4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2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 (4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4 (4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5 (4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 (4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70 (4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3337915711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Vascular Invasio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480081875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No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 (5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 (6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86 (6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8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 (6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1 (5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0 (6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3 (6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77 (5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722961134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Yes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8 (3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 (3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1 (3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2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2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8 (4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 (2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1 (3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29 (3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3675676692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Unknow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1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3 (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1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8 (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4130751333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Histological Type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128525387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DC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7 (10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 (8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98 (8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8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5 (8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45 (8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1 (9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1 (8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43 (8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2982415407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LC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1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5 (1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1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 (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1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7 (1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46231888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Other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 (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7 (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2868248882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Unknow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2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7 (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354971858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PgR % Baseline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002842063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Media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5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577326003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&lt;1%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5 (9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6 (8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3 (1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10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4 (8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4 (2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0 (9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0 (8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97 (1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3325556494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≥1%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1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17 (8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 (1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0 (7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 (1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37 (85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448098849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Ki67 % Baseline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578219232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Median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5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3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5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6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6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8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8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4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5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759403119"/>
                  </a:ext>
                </a:extLst>
              </a:tr>
              <a:tr h="149492">
                <a:tc gridSpan="10"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Ki67 response categories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09803921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R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98 (4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7 (2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45 (39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045701017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R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0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23 (2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 (2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1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66 (4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3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 (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89 (3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648725415"/>
                  </a:ext>
                </a:extLst>
              </a:tr>
              <a:tr h="149492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PR</a:t>
                      </a:r>
                      <a:endParaRPr lang="en-GB" sz="9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26 (96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8 (10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49 (32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4 (80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15 (88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51 (31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0 (97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>
                          <a:effectLst/>
                        </a:rPr>
                        <a:t>33 (94%)</a:t>
                      </a:r>
                      <a:endParaRPr lang="en-GB" sz="9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u="none" strike="noStrike" dirty="0">
                          <a:effectLst/>
                        </a:rPr>
                        <a:t>200 (31%)</a:t>
                      </a:r>
                      <a:endParaRPr lang="en-GB" sz="9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094" marR="6094" marT="6094" marB="0" anchor="b"/>
                </a:tc>
                <a:extLst>
                  <a:ext uri="{0D108BD9-81ED-4DB2-BD59-A6C34878D82A}">
                    <a16:rowId xmlns:a16="http://schemas.microsoft.com/office/drawing/2014/main" xmlns="" val="10230658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755323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259123" y="143474"/>
            <a:ext cx="9342077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Table S2</a:t>
            </a:r>
            <a:r>
              <a:rPr lang="en-GB" sz="1200" b="1" dirty="0"/>
              <a:t>. </a:t>
            </a:r>
            <a:r>
              <a:rPr lang="en-US" sz="1200" dirty="0"/>
              <a:t>Original (A) and derived (B) numbers (GR and IR of the HER2- population are multiplied by 3.3 which yields some fractional estimates for the number of patients) of ER IHC categories in the overall population and separated by HER2 status. </a:t>
            </a:r>
            <a:endParaRPr lang="en-GB" sz="1200" dirty="0"/>
          </a:p>
          <a:p>
            <a:r>
              <a:rPr lang="en-GB" sz="1200" b="1" dirty="0"/>
              <a:t>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13309" y="580885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13309" y="3471599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6593557"/>
              </p:ext>
            </p:extLst>
          </p:nvPr>
        </p:nvGraphicFramePr>
        <p:xfrm>
          <a:off x="645135" y="719384"/>
          <a:ext cx="4495798" cy="25908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49203">
                  <a:extLst>
                    <a:ext uri="{9D8B030D-6E8A-4147-A177-3AD203B41FA5}">
                      <a16:colId xmlns:a16="http://schemas.microsoft.com/office/drawing/2014/main" xmlns="" val="465161670"/>
                    </a:ext>
                  </a:extLst>
                </a:gridCol>
                <a:gridCol w="335269">
                  <a:extLst>
                    <a:ext uri="{9D8B030D-6E8A-4147-A177-3AD203B41FA5}">
                      <a16:colId xmlns:a16="http://schemas.microsoft.com/office/drawing/2014/main" xmlns="" val="3624296859"/>
                    </a:ext>
                  </a:extLst>
                </a:gridCol>
                <a:gridCol w="488535">
                  <a:extLst>
                    <a:ext uri="{9D8B030D-6E8A-4147-A177-3AD203B41FA5}">
                      <a16:colId xmlns:a16="http://schemas.microsoft.com/office/drawing/2014/main" xmlns="" val="3037572848"/>
                    </a:ext>
                  </a:extLst>
                </a:gridCol>
                <a:gridCol w="440639">
                  <a:extLst>
                    <a:ext uri="{9D8B030D-6E8A-4147-A177-3AD203B41FA5}">
                      <a16:colId xmlns:a16="http://schemas.microsoft.com/office/drawing/2014/main" xmlns="" val="1524060667"/>
                    </a:ext>
                  </a:extLst>
                </a:gridCol>
                <a:gridCol w="507693">
                  <a:extLst>
                    <a:ext uri="{9D8B030D-6E8A-4147-A177-3AD203B41FA5}">
                      <a16:colId xmlns:a16="http://schemas.microsoft.com/office/drawing/2014/main" xmlns="" val="212864030"/>
                    </a:ext>
                  </a:extLst>
                </a:gridCol>
                <a:gridCol w="507693">
                  <a:extLst>
                    <a:ext uri="{9D8B030D-6E8A-4147-A177-3AD203B41FA5}">
                      <a16:colId xmlns:a16="http://schemas.microsoft.com/office/drawing/2014/main" xmlns="" val="1546597935"/>
                    </a:ext>
                  </a:extLst>
                </a:gridCol>
                <a:gridCol w="507693">
                  <a:extLst>
                    <a:ext uri="{9D8B030D-6E8A-4147-A177-3AD203B41FA5}">
                      <a16:colId xmlns:a16="http://schemas.microsoft.com/office/drawing/2014/main" xmlns="" val="4125778444"/>
                    </a:ext>
                  </a:extLst>
                </a:gridCol>
                <a:gridCol w="507693">
                  <a:extLst>
                    <a:ext uri="{9D8B030D-6E8A-4147-A177-3AD203B41FA5}">
                      <a16:colId xmlns:a16="http://schemas.microsoft.com/office/drawing/2014/main" xmlns="" val="2034274965"/>
                    </a:ext>
                  </a:extLst>
                </a:gridCol>
                <a:gridCol w="325690">
                  <a:extLst>
                    <a:ext uri="{9D8B030D-6E8A-4147-A177-3AD203B41FA5}">
                      <a16:colId xmlns:a16="http://schemas.microsoft.com/office/drawing/2014/main" xmlns="" val="3193219728"/>
                    </a:ext>
                  </a:extLst>
                </a:gridCol>
                <a:gridCol w="325690">
                  <a:extLst>
                    <a:ext uri="{9D8B030D-6E8A-4147-A177-3AD203B41FA5}">
                      <a16:colId xmlns:a16="http://schemas.microsoft.com/office/drawing/2014/main" xmlns="" val="4068078474"/>
                    </a:ext>
                  </a:extLst>
                </a:gridCol>
              </a:tblGrid>
              <a:tr h="161925">
                <a:tc rowSpan="2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ER IHC %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04346359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 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 &lt; 1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 &lt; 1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0 &lt; 2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20 &lt; 4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40 &lt; 6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60 &lt; 8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80 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543808651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98986426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63507869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98831833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3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869647684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350697539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40180551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98467317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75309694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104287609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24532674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31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6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63544438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30478063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99839175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52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3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701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363543719"/>
                  </a:ext>
                </a:extLst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0934255"/>
              </p:ext>
            </p:extLst>
          </p:nvPr>
        </p:nvGraphicFramePr>
        <p:xfrm>
          <a:off x="645135" y="3621583"/>
          <a:ext cx="4927598" cy="25908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00462">
                  <a:extLst>
                    <a:ext uri="{9D8B030D-6E8A-4147-A177-3AD203B41FA5}">
                      <a16:colId xmlns:a16="http://schemas.microsoft.com/office/drawing/2014/main" xmlns="" val="2968401557"/>
                    </a:ext>
                  </a:extLst>
                </a:gridCol>
                <a:gridCol w="333590">
                  <a:extLst>
                    <a:ext uri="{9D8B030D-6E8A-4147-A177-3AD203B41FA5}">
                      <a16:colId xmlns:a16="http://schemas.microsoft.com/office/drawing/2014/main" xmlns="" val="338201722"/>
                    </a:ext>
                  </a:extLst>
                </a:gridCol>
                <a:gridCol w="333590">
                  <a:extLst>
                    <a:ext uri="{9D8B030D-6E8A-4147-A177-3AD203B41FA5}">
                      <a16:colId xmlns:a16="http://schemas.microsoft.com/office/drawing/2014/main" xmlns="" val="2292532554"/>
                    </a:ext>
                  </a:extLst>
                </a:gridCol>
                <a:gridCol w="505150">
                  <a:extLst>
                    <a:ext uri="{9D8B030D-6E8A-4147-A177-3AD203B41FA5}">
                      <a16:colId xmlns:a16="http://schemas.microsoft.com/office/drawing/2014/main" xmlns="" val="3319140927"/>
                    </a:ext>
                  </a:extLst>
                </a:gridCol>
                <a:gridCol w="505150">
                  <a:extLst>
                    <a:ext uri="{9D8B030D-6E8A-4147-A177-3AD203B41FA5}">
                      <a16:colId xmlns:a16="http://schemas.microsoft.com/office/drawing/2014/main" xmlns="" val="4217009331"/>
                    </a:ext>
                  </a:extLst>
                </a:gridCol>
                <a:gridCol w="505150">
                  <a:extLst>
                    <a:ext uri="{9D8B030D-6E8A-4147-A177-3AD203B41FA5}">
                      <a16:colId xmlns:a16="http://schemas.microsoft.com/office/drawing/2014/main" xmlns="" val="2869288607"/>
                    </a:ext>
                  </a:extLst>
                </a:gridCol>
                <a:gridCol w="571868">
                  <a:extLst>
                    <a:ext uri="{9D8B030D-6E8A-4147-A177-3AD203B41FA5}">
                      <a16:colId xmlns:a16="http://schemas.microsoft.com/office/drawing/2014/main" xmlns="" val="2705080247"/>
                    </a:ext>
                  </a:extLst>
                </a:gridCol>
                <a:gridCol w="638586">
                  <a:extLst>
                    <a:ext uri="{9D8B030D-6E8A-4147-A177-3AD203B41FA5}">
                      <a16:colId xmlns:a16="http://schemas.microsoft.com/office/drawing/2014/main" xmlns="" val="487937674"/>
                    </a:ext>
                  </a:extLst>
                </a:gridCol>
                <a:gridCol w="467026">
                  <a:extLst>
                    <a:ext uri="{9D8B030D-6E8A-4147-A177-3AD203B41FA5}">
                      <a16:colId xmlns:a16="http://schemas.microsoft.com/office/drawing/2014/main" xmlns="" val="1287819843"/>
                    </a:ext>
                  </a:extLst>
                </a:gridCol>
                <a:gridCol w="467026">
                  <a:extLst>
                    <a:ext uri="{9D8B030D-6E8A-4147-A177-3AD203B41FA5}">
                      <a16:colId xmlns:a16="http://schemas.microsoft.com/office/drawing/2014/main" xmlns="" val="3503481725"/>
                    </a:ext>
                  </a:extLst>
                </a:gridCol>
              </a:tblGrid>
              <a:tr h="161925">
                <a:tc rowSpan="2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ER IHC %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24940302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 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 &lt; 1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 &lt; 1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0 &lt; 2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20 &lt; 4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40 &lt; 6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60 &lt; 8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80 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898181634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68133151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.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9.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0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09.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64129430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.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5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31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53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78279595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5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0.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16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55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937506218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1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926595898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79413270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56242111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256168198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967727063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1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555749737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TOTAL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6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67763047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.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8.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3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78.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763300077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.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3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67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00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82072621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5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2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9.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10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441.6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8651719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46897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7598294"/>
              </p:ext>
            </p:extLst>
          </p:nvPr>
        </p:nvGraphicFramePr>
        <p:xfrm>
          <a:off x="536762" y="654222"/>
          <a:ext cx="5092701" cy="340042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372858">
                  <a:extLst>
                    <a:ext uri="{9D8B030D-6E8A-4147-A177-3AD203B41FA5}">
                      <a16:colId xmlns:a16="http://schemas.microsoft.com/office/drawing/2014/main" xmlns="" val="1579178017"/>
                    </a:ext>
                  </a:extLst>
                </a:gridCol>
                <a:gridCol w="336482">
                  <a:extLst>
                    <a:ext uri="{9D8B030D-6E8A-4147-A177-3AD203B41FA5}">
                      <a16:colId xmlns:a16="http://schemas.microsoft.com/office/drawing/2014/main" xmlns="" val="3594351244"/>
                    </a:ext>
                  </a:extLst>
                </a:gridCol>
                <a:gridCol w="318294">
                  <a:extLst>
                    <a:ext uri="{9D8B030D-6E8A-4147-A177-3AD203B41FA5}">
                      <a16:colId xmlns:a16="http://schemas.microsoft.com/office/drawing/2014/main" xmlns="" val="3188426786"/>
                    </a:ext>
                  </a:extLst>
                </a:gridCol>
                <a:gridCol w="300106">
                  <a:extLst>
                    <a:ext uri="{9D8B030D-6E8A-4147-A177-3AD203B41FA5}">
                      <a16:colId xmlns:a16="http://schemas.microsoft.com/office/drawing/2014/main" xmlns="" val="4000811537"/>
                    </a:ext>
                  </a:extLst>
                </a:gridCol>
                <a:gridCol w="481988">
                  <a:extLst>
                    <a:ext uri="{9D8B030D-6E8A-4147-A177-3AD203B41FA5}">
                      <a16:colId xmlns:a16="http://schemas.microsoft.com/office/drawing/2014/main" xmlns="" val="535548503"/>
                    </a:ext>
                  </a:extLst>
                </a:gridCol>
                <a:gridCol w="481988">
                  <a:extLst>
                    <a:ext uri="{9D8B030D-6E8A-4147-A177-3AD203B41FA5}">
                      <a16:colId xmlns:a16="http://schemas.microsoft.com/office/drawing/2014/main" xmlns="" val="4265253624"/>
                    </a:ext>
                  </a:extLst>
                </a:gridCol>
                <a:gridCol w="481988">
                  <a:extLst>
                    <a:ext uri="{9D8B030D-6E8A-4147-A177-3AD203B41FA5}">
                      <a16:colId xmlns:a16="http://schemas.microsoft.com/office/drawing/2014/main" xmlns="" val="3503003618"/>
                    </a:ext>
                  </a:extLst>
                </a:gridCol>
                <a:gridCol w="545646">
                  <a:extLst>
                    <a:ext uri="{9D8B030D-6E8A-4147-A177-3AD203B41FA5}">
                      <a16:colId xmlns:a16="http://schemas.microsoft.com/office/drawing/2014/main" xmlns="" val="4127154252"/>
                    </a:ext>
                  </a:extLst>
                </a:gridCol>
                <a:gridCol w="609305">
                  <a:extLst>
                    <a:ext uri="{9D8B030D-6E8A-4147-A177-3AD203B41FA5}">
                      <a16:colId xmlns:a16="http://schemas.microsoft.com/office/drawing/2014/main" xmlns="" val="3396919318"/>
                    </a:ext>
                  </a:extLst>
                </a:gridCol>
                <a:gridCol w="582023">
                  <a:extLst>
                    <a:ext uri="{9D8B030D-6E8A-4147-A177-3AD203B41FA5}">
                      <a16:colId xmlns:a16="http://schemas.microsoft.com/office/drawing/2014/main" xmlns="" val="4203718046"/>
                    </a:ext>
                  </a:extLst>
                </a:gridCol>
                <a:gridCol w="582023">
                  <a:extLst>
                    <a:ext uri="{9D8B030D-6E8A-4147-A177-3AD203B41FA5}">
                      <a16:colId xmlns:a16="http://schemas.microsoft.com/office/drawing/2014/main" xmlns="" val="4167137328"/>
                    </a:ext>
                  </a:extLst>
                </a:gridCol>
              </a:tblGrid>
              <a:tr h="161925">
                <a:tc rowSpan="2" gridSpan="2"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rowSpan="2"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ER IHC %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889508930"/>
                  </a:ext>
                </a:extLst>
              </a:tr>
              <a:tr h="161925">
                <a:tc gridSpan="2"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 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 &lt; 1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 &lt; 1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0 &lt; 2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20 &lt; 4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40 &lt; 6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60 &lt; 80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80 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Total</a:t>
                      </a:r>
                      <a:endParaRPr lang="en-GB" sz="1000" b="1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51318245"/>
                  </a:ext>
                </a:extLst>
              </a:tr>
              <a:tr h="161925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 err="1">
                          <a:effectLst/>
                        </a:rPr>
                        <a:t>PgR</a:t>
                      </a:r>
                      <a:r>
                        <a:rPr lang="en-GB" sz="1000" u="none" strike="noStrike" dirty="0">
                          <a:effectLst/>
                        </a:rPr>
                        <a:t>-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09293547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36974084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92278883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27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42455557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06711784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gR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34716568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5850866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50073648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2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268485652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gridSpan="10"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416830878"/>
                  </a:ext>
                </a:extLst>
              </a:tr>
              <a:tr h="161925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gR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6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02223431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24099052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09430403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07631218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10">
                  <a:txBody>
                    <a:bodyPr/>
                    <a:lstStyle/>
                    <a:p>
                      <a:pPr algn="ctr" fontAlgn="b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33362571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 err="1">
                          <a:effectLst/>
                        </a:rPr>
                        <a:t>PgR</a:t>
                      </a:r>
                      <a:r>
                        <a:rPr lang="en-GB" sz="1000" u="none" strike="noStrike" dirty="0">
                          <a:effectLst/>
                        </a:rPr>
                        <a:t>+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698200940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18942177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761647777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 dirty="0">
                          <a:effectLst/>
                        </a:rPr>
                        <a:t>0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23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92171457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49509" y="67474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46519" y="4270580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59122" y="143474"/>
            <a:ext cx="9275403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Table S3</a:t>
            </a:r>
            <a:r>
              <a:rPr lang="en-GB" sz="1200" b="1" dirty="0"/>
              <a:t>. </a:t>
            </a:r>
            <a:r>
              <a:rPr lang="en-US" sz="1200" dirty="0"/>
              <a:t>Original (A) and derived (B) numbers (GR and IR of the HER2- population are multiplied by 3.3 which yields some fractional estimates for the number of patients) of ER IHC categories in the overall population and separated by </a:t>
            </a:r>
            <a:r>
              <a:rPr lang="en-US" sz="1200" dirty="0" err="1"/>
              <a:t>PgR</a:t>
            </a:r>
            <a:r>
              <a:rPr lang="en-US" sz="1200" dirty="0"/>
              <a:t> status. </a:t>
            </a:r>
            <a:endParaRPr lang="en-GB" sz="1200" dirty="0"/>
          </a:p>
          <a:p>
            <a:endParaRPr lang="en-GB" sz="1200" b="1" dirty="0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7462073"/>
              </p:ext>
            </p:extLst>
          </p:nvPr>
        </p:nvGraphicFramePr>
        <p:xfrm>
          <a:off x="527149" y="4255747"/>
          <a:ext cx="5435599" cy="25908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89137">
                  <a:extLst>
                    <a:ext uri="{9D8B030D-6E8A-4147-A177-3AD203B41FA5}">
                      <a16:colId xmlns:a16="http://schemas.microsoft.com/office/drawing/2014/main" xmlns="" val="288816779"/>
                    </a:ext>
                  </a:extLst>
                </a:gridCol>
                <a:gridCol w="512466">
                  <a:extLst>
                    <a:ext uri="{9D8B030D-6E8A-4147-A177-3AD203B41FA5}">
                      <a16:colId xmlns:a16="http://schemas.microsoft.com/office/drawing/2014/main" xmlns="" val="2686343426"/>
                    </a:ext>
                  </a:extLst>
                </a:gridCol>
                <a:gridCol w="481139">
                  <a:extLst>
                    <a:ext uri="{9D8B030D-6E8A-4147-A177-3AD203B41FA5}">
                      <a16:colId xmlns:a16="http://schemas.microsoft.com/office/drawing/2014/main" xmlns="" val="4279936972"/>
                    </a:ext>
                  </a:extLst>
                </a:gridCol>
                <a:gridCol w="492737">
                  <a:extLst>
                    <a:ext uri="{9D8B030D-6E8A-4147-A177-3AD203B41FA5}">
                      <a16:colId xmlns:a16="http://schemas.microsoft.com/office/drawing/2014/main" xmlns="" val="2428639045"/>
                    </a:ext>
                  </a:extLst>
                </a:gridCol>
                <a:gridCol w="492737">
                  <a:extLst>
                    <a:ext uri="{9D8B030D-6E8A-4147-A177-3AD203B41FA5}">
                      <a16:colId xmlns:a16="http://schemas.microsoft.com/office/drawing/2014/main" xmlns="" val="3336700131"/>
                    </a:ext>
                  </a:extLst>
                </a:gridCol>
                <a:gridCol w="492737">
                  <a:extLst>
                    <a:ext uri="{9D8B030D-6E8A-4147-A177-3AD203B41FA5}">
                      <a16:colId xmlns:a16="http://schemas.microsoft.com/office/drawing/2014/main" xmlns="" val="1203937825"/>
                    </a:ext>
                  </a:extLst>
                </a:gridCol>
                <a:gridCol w="557815">
                  <a:extLst>
                    <a:ext uri="{9D8B030D-6E8A-4147-A177-3AD203B41FA5}">
                      <a16:colId xmlns:a16="http://schemas.microsoft.com/office/drawing/2014/main" xmlns="" val="3818518372"/>
                    </a:ext>
                  </a:extLst>
                </a:gridCol>
                <a:gridCol w="622894">
                  <a:extLst>
                    <a:ext uri="{9D8B030D-6E8A-4147-A177-3AD203B41FA5}">
                      <a16:colId xmlns:a16="http://schemas.microsoft.com/office/drawing/2014/main" xmlns="" val="3571818518"/>
                    </a:ext>
                  </a:extLst>
                </a:gridCol>
                <a:gridCol w="545419">
                  <a:extLst>
                    <a:ext uri="{9D8B030D-6E8A-4147-A177-3AD203B41FA5}">
                      <a16:colId xmlns:a16="http://schemas.microsoft.com/office/drawing/2014/main" xmlns="" val="1154916829"/>
                    </a:ext>
                  </a:extLst>
                </a:gridCol>
                <a:gridCol w="548518">
                  <a:extLst>
                    <a:ext uri="{9D8B030D-6E8A-4147-A177-3AD203B41FA5}">
                      <a16:colId xmlns:a16="http://schemas.microsoft.com/office/drawing/2014/main" xmlns="" val="1434884073"/>
                    </a:ext>
                  </a:extLst>
                </a:gridCol>
              </a:tblGrid>
              <a:tr h="161925">
                <a:tc rowSpan="2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ER IHC %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329708499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 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 &lt; 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 &lt; 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0 &lt; 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20 &lt; 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40 &lt; 6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60 &lt; 8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80 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Total</a:t>
                      </a:r>
                      <a:endParaRPr lang="en-GB" sz="1000" b="1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52105671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 err="1">
                          <a:effectLst/>
                        </a:rPr>
                        <a:t>PgR</a:t>
                      </a:r>
                      <a:r>
                        <a:rPr lang="en-GB" sz="1000" u="none" strike="noStrike" dirty="0">
                          <a:effectLst/>
                        </a:rPr>
                        <a:t>-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.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70531671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3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09988201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9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589974047"/>
                  </a:ext>
                </a:extLst>
              </a:tr>
              <a:tr h="78321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2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.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1.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05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170902247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160411473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 err="1">
                          <a:effectLst/>
                        </a:rPr>
                        <a:t>PgR</a:t>
                      </a:r>
                      <a:r>
                        <a:rPr lang="en-GB" sz="1000" u="none" strike="noStrike" dirty="0">
                          <a:effectLst/>
                        </a:rPr>
                        <a:t>+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2.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6360208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7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3.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24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90647903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.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9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32.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60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541647970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9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7.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28.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36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425035070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27225535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AL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9.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6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053136588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.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8.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3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78.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18383531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.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3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67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00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06255854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5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2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9.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10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441.6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7070728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4554167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80" b="12615"/>
          <a:stretch/>
        </p:blipFill>
        <p:spPr>
          <a:xfrm>
            <a:off x="530679" y="944499"/>
            <a:ext cx="3796776" cy="269717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1" b="13008"/>
          <a:stretch/>
        </p:blipFill>
        <p:spPr>
          <a:xfrm>
            <a:off x="4386570" y="956633"/>
            <a:ext cx="3827848" cy="2685040"/>
          </a:xfrm>
          <a:prstGeom prst="rect">
            <a:avLst/>
          </a:prstGeom>
        </p:spPr>
      </p:pic>
      <p:cxnSp>
        <p:nvCxnSpPr>
          <p:cNvPr id="12" name="Straight Connector 11"/>
          <p:cNvCxnSpPr/>
          <p:nvPr/>
        </p:nvCxnSpPr>
        <p:spPr>
          <a:xfrm flipV="1">
            <a:off x="2953564" y="1331230"/>
            <a:ext cx="0" cy="223200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V="1">
            <a:off x="1888789" y="1331230"/>
            <a:ext cx="0" cy="223200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/>
          <p:cNvCxnSpPr/>
          <p:nvPr/>
        </p:nvCxnSpPr>
        <p:spPr>
          <a:xfrm flipV="1">
            <a:off x="6834924" y="1335690"/>
            <a:ext cx="0" cy="223200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 flipV="1">
            <a:off x="5775104" y="1331230"/>
            <a:ext cx="0" cy="2232000"/>
          </a:xfrm>
          <a:prstGeom prst="line">
            <a:avLst/>
          </a:prstGeom>
          <a:ln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685322" y="3628109"/>
            <a:ext cx="3881125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0%	   	      1%	        	            10%	   	                  100%</a:t>
            </a:r>
            <a:endParaRPr lang="en-GB" sz="800" dirty="0"/>
          </a:p>
        </p:txBody>
      </p:sp>
      <p:sp>
        <p:nvSpPr>
          <p:cNvPr id="22" name="TextBox 21"/>
          <p:cNvSpPr txBox="1"/>
          <p:nvPr/>
        </p:nvSpPr>
        <p:spPr>
          <a:xfrm>
            <a:off x="4610593" y="3592163"/>
            <a:ext cx="402357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0%	   	     1%	        	           10%	                                     100%</a:t>
            </a:r>
            <a:endParaRPr lang="en-GB" sz="800" dirty="0"/>
          </a:p>
        </p:txBody>
      </p:sp>
      <p:sp>
        <p:nvSpPr>
          <p:cNvPr id="26" name="TextBox 25"/>
          <p:cNvSpPr txBox="1"/>
          <p:nvPr/>
        </p:nvSpPr>
        <p:spPr>
          <a:xfrm>
            <a:off x="190543" y="172478"/>
            <a:ext cx="9376079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Figure S2</a:t>
            </a:r>
            <a:r>
              <a:rPr lang="en-GB" sz="1200" b="1" dirty="0"/>
              <a:t>. </a:t>
            </a:r>
            <a:r>
              <a:rPr lang="en-US" sz="1200" dirty="0"/>
              <a:t>Scatterplots of ER IHC in relation to Ki67 in </a:t>
            </a:r>
            <a:r>
              <a:rPr lang="en-US" sz="1200" dirty="0" err="1"/>
              <a:t>PgR</a:t>
            </a:r>
            <a:r>
              <a:rPr lang="en-US" sz="1200" dirty="0"/>
              <a:t>- (A) and </a:t>
            </a:r>
            <a:r>
              <a:rPr lang="en-US" sz="1200" dirty="0" err="1"/>
              <a:t>PgR</a:t>
            </a:r>
            <a:r>
              <a:rPr lang="en-US" sz="1200" dirty="0"/>
              <a:t> + (B) using 10% as a threshold for positivity.</a:t>
            </a:r>
            <a:endParaRPr lang="en-GB" sz="1200" dirty="0"/>
          </a:p>
          <a:p>
            <a:endParaRPr lang="en-GB" sz="1200" b="1" dirty="0"/>
          </a:p>
        </p:txBody>
      </p:sp>
      <p:sp>
        <p:nvSpPr>
          <p:cNvPr id="27" name="TextBox 26"/>
          <p:cNvSpPr txBox="1"/>
          <p:nvPr/>
        </p:nvSpPr>
        <p:spPr>
          <a:xfrm rot="16200000">
            <a:off x="-67535" y="2337922"/>
            <a:ext cx="83708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% Ki67 Residual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196422" y="3720028"/>
            <a:ext cx="4571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ER IHC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100352" y="3720028"/>
            <a:ext cx="4571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ER IHC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54179" y="958280"/>
            <a:ext cx="644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. </a:t>
            </a:r>
            <a:r>
              <a:rPr lang="en-GB" sz="1200" b="1" dirty="0" err="1"/>
              <a:t>PgR</a:t>
            </a:r>
            <a:r>
              <a:rPr lang="en-GB" sz="1200" b="1" dirty="0"/>
              <a:t>-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720176" y="958280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. </a:t>
            </a:r>
            <a:r>
              <a:rPr lang="en-GB" sz="1200" b="1" dirty="0" err="1"/>
              <a:t>PgR</a:t>
            </a:r>
            <a:r>
              <a:rPr lang="en-GB" sz="1200" b="1" dirty="0"/>
              <a:t>+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631554" y="2306000"/>
            <a:ext cx="235688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/>
              <a:t>1%	        10%	                  100%	 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3237650" y="2355508"/>
            <a:ext cx="235688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/>
              <a:t>1%	        10%	                  100%	 </a:t>
            </a:r>
          </a:p>
        </p:txBody>
      </p:sp>
    </p:spTree>
    <p:extLst>
      <p:ext uri="{BB962C8B-B14F-4D97-AF65-F5344CB8AC3E}">
        <p14:creationId xmlns:p14="http://schemas.microsoft.com/office/powerpoint/2010/main" val="8486189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154348" y="143474"/>
            <a:ext cx="9618301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Table S4</a:t>
            </a:r>
            <a:r>
              <a:rPr lang="en-GB" sz="1200" b="1" dirty="0"/>
              <a:t>. </a:t>
            </a:r>
            <a:r>
              <a:rPr lang="en-US" sz="1200" dirty="0"/>
              <a:t>Original (A) and derived (B) numbers (GR and IR of the HER2- population are multiplied by 3.3 which yields some fractional estimates for the number of patients) of ER </a:t>
            </a:r>
            <a:r>
              <a:rPr lang="en-US" sz="1200" dirty="0" err="1"/>
              <a:t>rtPCR</a:t>
            </a:r>
            <a:r>
              <a:rPr lang="en-US" sz="1200" dirty="0"/>
              <a:t> relative expression categories in the overall population and separated by HER2 status. </a:t>
            </a:r>
            <a:endParaRPr lang="en-GB" sz="1200" dirty="0"/>
          </a:p>
          <a:p>
            <a:endParaRPr lang="en-GB" sz="12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148978" y="557323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48978" y="3586131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36421946"/>
              </p:ext>
            </p:extLst>
          </p:nvPr>
        </p:nvGraphicFramePr>
        <p:xfrm>
          <a:off x="477639" y="635623"/>
          <a:ext cx="4495798" cy="27432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49203">
                  <a:extLst>
                    <a:ext uri="{9D8B030D-6E8A-4147-A177-3AD203B41FA5}">
                      <a16:colId xmlns:a16="http://schemas.microsoft.com/office/drawing/2014/main" xmlns="" val="4069471437"/>
                    </a:ext>
                  </a:extLst>
                </a:gridCol>
                <a:gridCol w="335269">
                  <a:extLst>
                    <a:ext uri="{9D8B030D-6E8A-4147-A177-3AD203B41FA5}">
                      <a16:colId xmlns:a16="http://schemas.microsoft.com/office/drawing/2014/main" xmlns="" val="3101677215"/>
                    </a:ext>
                  </a:extLst>
                </a:gridCol>
                <a:gridCol w="488535">
                  <a:extLst>
                    <a:ext uri="{9D8B030D-6E8A-4147-A177-3AD203B41FA5}">
                      <a16:colId xmlns:a16="http://schemas.microsoft.com/office/drawing/2014/main" xmlns="" val="1117220064"/>
                    </a:ext>
                  </a:extLst>
                </a:gridCol>
                <a:gridCol w="440639">
                  <a:extLst>
                    <a:ext uri="{9D8B030D-6E8A-4147-A177-3AD203B41FA5}">
                      <a16:colId xmlns:a16="http://schemas.microsoft.com/office/drawing/2014/main" xmlns="" val="3774902465"/>
                    </a:ext>
                  </a:extLst>
                </a:gridCol>
                <a:gridCol w="507693">
                  <a:extLst>
                    <a:ext uri="{9D8B030D-6E8A-4147-A177-3AD203B41FA5}">
                      <a16:colId xmlns:a16="http://schemas.microsoft.com/office/drawing/2014/main" xmlns="" val="1047865040"/>
                    </a:ext>
                  </a:extLst>
                </a:gridCol>
                <a:gridCol w="507693">
                  <a:extLst>
                    <a:ext uri="{9D8B030D-6E8A-4147-A177-3AD203B41FA5}">
                      <a16:colId xmlns:a16="http://schemas.microsoft.com/office/drawing/2014/main" xmlns="" val="3582161062"/>
                    </a:ext>
                  </a:extLst>
                </a:gridCol>
                <a:gridCol w="507693">
                  <a:extLst>
                    <a:ext uri="{9D8B030D-6E8A-4147-A177-3AD203B41FA5}">
                      <a16:colId xmlns:a16="http://schemas.microsoft.com/office/drawing/2014/main" xmlns="" val="1859742033"/>
                    </a:ext>
                  </a:extLst>
                </a:gridCol>
                <a:gridCol w="507693">
                  <a:extLst>
                    <a:ext uri="{9D8B030D-6E8A-4147-A177-3AD203B41FA5}">
                      <a16:colId xmlns:a16="http://schemas.microsoft.com/office/drawing/2014/main" xmlns="" val="1903085025"/>
                    </a:ext>
                  </a:extLst>
                </a:gridCol>
                <a:gridCol w="325690">
                  <a:extLst>
                    <a:ext uri="{9D8B030D-6E8A-4147-A177-3AD203B41FA5}">
                      <a16:colId xmlns:a16="http://schemas.microsoft.com/office/drawing/2014/main" xmlns="" val="1293897109"/>
                    </a:ext>
                  </a:extLst>
                </a:gridCol>
                <a:gridCol w="325690">
                  <a:extLst>
                    <a:ext uri="{9D8B030D-6E8A-4147-A177-3AD203B41FA5}">
                      <a16:colId xmlns:a16="http://schemas.microsoft.com/office/drawing/2014/main" xmlns="" val="667858448"/>
                    </a:ext>
                  </a:extLst>
                </a:gridCol>
              </a:tblGrid>
              <a:tr h="161925">
                <a:tc rowSpan="2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ER qPCR relative expression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45924469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 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&lt;5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5 &lt; 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0 &lt; 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20 &lt; 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40 &lt; 8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80 &lt; 1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20 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969227894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70687758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57527908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9290468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6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427029481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851439073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151496397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41595293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61981746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301566480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837354265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TOTAL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96529328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12956364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65966021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538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922218562"/>
                  </a:ext>
                </a:extLst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2678743"/>
              </p:ext>
            </p:extLst>
          </p:nvPr>
        </p:nvGraphicFramePr>
        <p:xfrm>
          <a:off x="486904" y="3674289"/>
          <a:ext cx="5041903" cy="2716281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03878">
                  <a:extLst>
                    <a:ext uri="{9D8B030D-6E8A-4147-A177-3AD203B41FA5}">
                      <a16:colId xmlns:a16="http://schemas.microsoft.com/office/drawing/2014/main" xmlns="" val="1341634248"/>
                    </a:ext>
                  </a:extLst>
                </a:gridCol>
                <a:gridCol w="335488">
                  <a:extLst>
                    <a:ext uri="{9D8B030D-6E8A-4147-A177-3AD203B41FA5}">
                      <a16:colId xmlns:a16="http://schemas.microsoft.com/office/drawing/2014/main" xmlns="" val="1282003172"/>
                    </a:ext>
                  </a:extLst>
                </a:gridCol>
                <a:gridCol w="364244">
                  <a:extLst>
                    <a:ext uri="{9D8B030D-6E8A-4147-A177-3AD203B41FA5}">
                      <a16:colId xmlns:a16="http://schemas.microsoft.com/office/drawing/2014/main" xmlns="" val="3244807656"/>
                    </a:ext>
                  </a:extLst>
                </a:gridCol>
                <a:gridCol w="517610">
                  <a:extLst>
                    <a:ext uri="{9D8B030D-6E8A-4147-A177-3AD203B41FA5}">
                      <a16:colId xmlns:a16="http://schemas.microsoft.com/office/drawing/2014/main" xmlns="" val="3508961416"/>
                    </a:ext>
                  </a:extLst>
                </a:gridCol>
                <a:gridCol w="517610">
                  <a:extLst>
                    <a:ext uri="{9D8B030D-6E8A-4147-A177-3AD203B41FA5}">
                      <a16:colId xmlns:a16="http://schemas.microsoft.com/office/drawing/2014/main" xmlns="" val="1178855172"/>
                    </a:ext>
                  </a:extLst>
                </a:gridCol>
                <a:gridCol w="517610">
                  <a:extLst>
                    <a:ext uri="{9D8B030D-6E8A-4147-A177-3AD203B41FA5}">
                      <a16:colId xmlns:a16="http://schemas.microsoft.com/office/drawing/2014/main" xmlns="" val="3628855635"/>
                    </a:ext>
                  </a:extLst>
                </a:gridCol>
                <a:gridCol w="584707">
                  <a:extLst>
                    <a:ext uri="{9D8B030D-6E8A-4147-A177-3AD203B41FA5}">
                      <a16:colId xmlns:a16="http://schemas.microsoft.com/office/drawing/2014/main" xmlns="" val="4042945983"/>
                    </a:ext>
                  </a:extLst>
                </a:gridCol>
                <a:gridCol w="651805">
                  <a:extLst>
                    <a:ext uri="{9D8B030D-6E8A-4147-A177-3AD203B41FA5}">
                      <a16:colId xmlns:a16="http://schemas.microsoft.com/office/drawing/2014/main" xmlns="" val="1184623388"/>
                    </a:ext>
                  </a:extLst>
                </a:gridCol>
                <a:gridCol w="479268">
                  <a:extLst>
                    <a:ext uri="{9D8B030D-6E8A-4147-A177-3AD203B41FA5}">
                      <a16:colId xmlns:a16="http://schemas.microsoft.com/office/drawing/2014/main" xmlns="" val="2905008216"/>
                    </a:ext>
                  </a:extLst>
                </a:gridCol>
                <a:gridCol w="469683">
                  <a:extLst>
                    <a:ext uri="{9D8B030D-6E8A-4147-A177-3AD203B41FA5}">
                      <a16:colId xmlns:a16="http://schemas.microsoft.com/office/drawing/2014/main" xmlns="" val="487023868"/>
                    </a:ext>
                  </a:extLst>
                </a:gridCol>
              </a:tblGrid>
              <a:tr h="161925">
                <a:tc rowSpan="2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ER qPCR relative expression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920579115"/>
                  </a:ext>
                </a:extLst>
              </a:tr>
              <a:tr h="287406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 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&lt;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5 &lt; 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0 &lt; 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20 &lt; 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40 &lt; 8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≥80 &lt; 120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20 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886302843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90214370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2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9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5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67180068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9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9.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20.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88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965554480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7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1.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4.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4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04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14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296850122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754874241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12106320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9846628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514979610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038376523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346420588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6261243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2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8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2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7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6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165726151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2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6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6.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4.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33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513487337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5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6.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9.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8.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7.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50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085.4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7440283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364136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7097524"/>
              </p:ext>
            </p:extLst>
          </p:nvPr>
        </p:nvGraphicFramePr>
        <p:xfrm>
          <a:off x="640730" y="690899"/>
          <a:ext cx="6705600" cy="3400425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609600">
                  <a:extLst>
                    <a:ext uri="{9D8B030D-6E8A-4147-A177-3AD203B41FA5}">
                      <a16:colId xmlns:a16="http://schemas.microsoft.com/office/drawing/2014/main" xmlns="" val="344062530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73092026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46713896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341025502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3627496069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78030814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179185654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576708218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479249076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281370123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xmlns="" val="1827703303"/>
                    </a:ext>
                  </a:extLst>
                </a:gridCol>
              </a:tblGrid>
              <a:tr h="161925">
                <a:tc rowSpan="2" gridSpan="2"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rowSpan="2"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ER qPCR relative expression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113433401"/>
                  </a:ext>
                </a:extLst>
              </a:tr>
              <a:tr h="161925">
                <a:tc gridSpan="2"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 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&lt;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0 &lt; 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20 &lt; 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40 &lt; 8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≥80 &lt; 120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20 &lt; 16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60 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1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198549645"/>
                  </a:ext>
                </a:extLst>
              </a:tr>
              <a:tr h="161925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HER2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355533786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5746041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19745569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85971130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97807682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3396430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16864043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890752197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7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0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879869256"/>
                  </a:ext>
                </a:extLst>
              </a:tr>
              <a:tr h="161925">
                <a:tc gridSpan="10"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039770132"/>
                  </a:ext>
                </a:extLst>
              </a:tr>
              <a:tr h="161925">
                <a:tc row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HER2+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5867704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47336399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30607546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82725324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9"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248212548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820170348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587163529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54476633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6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9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1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15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97662207"/>
                  </a:ext>
                </a:extLst>
              </a:tr>
            </a:tbl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171450" y="143474"/>
            <a:ext cx="9610725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Table S5</a:t>
            </a:r>
            <a:r>
              <a:rPr lang="en-GB" sz="1200" b="1" dirty="0"/>
              <a:t>. </a:t>
            </a:r>
            <a:r>
              <a:rPr lang="en-US" sz="1200" dirty="0"/>
              <a:t>Original (A) and derived (B) numbers (GR and IR of the HER2- population are multiplied by 3.3 which yields some fractional estimates for the number of patients) of ER </a:t>
            </a:r>
            <a:r>
              <a:rPr lang="en-US" sz="1200" dirty="0" err="1"/>
              <a:t>rtPCR</a:t>
            </a:r>
            <a:r>
              <a:rPr lang="en-US" sz="1200" dirty="0"/>
              <a:t> relative expression categories in the overall population and separated by </a:t>
            </a:r>
            <a:r>
              <a:rPr lang="en-US" sz="1200" dirty="0" err="1"/>
              <a:t>PgR</a:t>
            </a:r>
            <a:r>
              <a:rPr lang="en-US" sz="1200" dirty="0"/>
              <a:t> status. </a:t>
            </a:r>
            <a:endParaRPr lang="en-GB" sz="1200" dirty="0"/>
          </a:p>
          <a:p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00229" y="60144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00229" y="4227971"/>
            <a:ext cx="2712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xmlns="" id="{80D0E6F4-CC1F-4839-8D14-9ABF3B0681A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0909934"/>
              </p:ext>
            </p:extLst>
          </p:nvPr>
        </p:nvGraphicFramePr>
        <p:xfrm>
          <a:off x="640730" y="4267200"/>
          <a:ext cx="5334000" cy="25908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333375">
                  <a:extLst>
                    <a:ext uri="{9D8B030D-6E8A-4147-A177-3AD203B41FA5}">
                      <a16:colId xmlns:a16="http://schemas.microsoft.com/office/drawing/2014/main" xmlns="" val="1712515485"/>
                    </a:ext>
                  </a:extLst>
                </a:gridCol>
                <a:gridCol w="504825">
                  <a:extLst>
                    <a:ext uri="{9D8B030D-6E8A-4147-A177-3AD203B41FA5}">
                      <a16:colId xmlns:a16="http://schemas.microsoft.com/office/drawing/2014/main" xmlns="" val="3077908722"/>
                    </a:ext>
                  </a:extLst>
                </a:gridCol>
                <a:gridCol w="504825">
                  <a:extLst>
                    <a:ext uri="{9D8B030D-6E8A-4147-A177-3AD203B41FA5}">
                      <a16:colId xmlns:a16="http://schemas.microsoft.com/office/drawing/2014/main" xmlns="" val="2636445595"/>
                    </a:ext>
                  </a:extLst>
                </a:gridCol>
                <a:gridCol w="504825">
                  <a:extLst>
                    <a:ext uri="{9D8B030D-6E8A-4147-A177-3AD203B41FA5}">
                      <a16:colId xmlns:a16="http://schemas.microsoft.com/office/drawing/2014/main" xmlns="" val="372116005"/>
                    </a:ext>
                  </a:extLst>
                </a:gridCol>
                <a:gridCol w="571500">
                  <a:extLst>
                    <a:ext uri="{9D8B030D-6E8A-4147-A177-3AD203B41FA5}">
                      <a16:colId xmlns:a16="http://schemas.microsoft.com/office/drawing/2014/main" xmlns="" val="1934416544"/>
                    </a:ext>
                  </a:extLst>
                </a:gridCol>
                <a:gridCol w="638175">
                  <a:extLst>
                    <a:ext uri="{9D8B030D-6E8A-4147-A177-3AD203B41FA5}">
                      <a16:colId xmlns:a16="http://schemas.microsoft.com/office/drawing/2014/main" xmlns="" val="2815169291"/>
                    </a:ext>
                  </a:extLst>
                </a:gridCol>
                <a:gridCol w="638175">
                  <a:extLst>
                    <a:ext uri="{9D8B030D-6E8A-4147-A177-3AD203B41FA5}">
                      <a16:colId xmlns:a16="http://schemas.microsoft.com/office/drawing/2014/main" xmlns="" val="2385163335"/>
                    </a:ext>
                  </a:extLst>
                </a:gridCol>
                <a:gridCol w="638175">
                  <a:extLst>
                    <a:ext uri="{9D8B030D-6E8A-4147-A177-3AD203B41FA5}">
                      <a16:colId xmlns:a16="http://schemas.microsoft.com/office/drawing/2014/main" xmlns="" val="1607176672"/>
                    </a:ext>
                  </a:extLst>
                </a:gridCol>
                <a:gridCol w="561975">
                  <a:extLst>
                    <a:ext uri="{9D8B030D-6E8A-4147-A177-3AD203B41FA5}">
                      <a16:colId xmlns:a16="http://schemas.microsoft.com/office/drawing/2014/main" xmlns="" val="2768469371"/>
                    </a:ext>
                  </a:extLst>
                </a:gridCol>
                <a:gridCol w="438150">
                  <a:extLst>
                    <a:ext uri="{9D8B030D-6E8A-4147-A177-3AD203B41FA5}">
                      <a16:colId xmlns:a16="http://schemas.microsoft.com/office/drawing/2014/main" xmlns="" val="257807420"/>
                    </a:ext>
                  </a:extLst>
                </a:gridCol>
              </a:tblGrid>
              <a:tr h="161925">
                <a:tc rowSpan="2"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ER qPCR relative expression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446683387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 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&lt;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5 &lt; 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0 &lt; 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20 &lt; 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40 &lt; 8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80 &lt; 1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≥120 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075486758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-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8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31291909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3.9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8.6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1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55765202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1.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9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631612013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2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9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3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3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4.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3.6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2.7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8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775974625"/>
                  </a:ext>
                </a:extLst>
              </a:tr>
              <a:tr h="161925">
                <a:tc gridSpan="9"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908845290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+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8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5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1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15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159303360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6.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6.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4.8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3.9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4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18.3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85172109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0.5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1.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5.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12.7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93.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239599055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9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23.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75.9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43.9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64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07.7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27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135910805"/>
                  </a:ext>
                </a:extLst>
              </a:tr>
              <a:tr h="161925">
                <a:tc gridSpan="9">
                  <a:txBody>
                    <a:bodyPr/>
                    <a:lstStyle/>
                    <a:p>
                      <a:pPr algn="ctr" fontAlgn="b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279471501"/>
                  </a:ext>
                </a:extLst>
              </a:tr>
              <a:tr h="161925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AL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P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1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2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4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3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9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92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1186222912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I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1.5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42.7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78.7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2.5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47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6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475724267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GR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0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1.0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22.5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66.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96.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344.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533.4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2454412694"/>
                  </a:ext>
                </a:extLst>
              </a:tr>
              <a:tr h="161925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>
                          <a:effectLst/>
                        </a:rPr>
                        <a:t>Total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45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8.3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36.5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89.2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68.1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177.6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u="none" strike="noStrike">
                          <a:effectLst/>
                        </a:rPr>
                        <a:t>550.40</a:t>
                      </a:r>
                      <a:endParaRPr lang="en-GB" sz="1000" b="0" i="0" u="none" strike="noStrike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000" u="none" strike="noStrike" dirty="0">
                          <a:effectLst/>
                        </a:rPr>
                        <a:t>1085.4</a:t>
                      </a:r>
                      <a:endParaRPr lang="en-GB" sz="1000" b="0" i="0" u="none" strike="noStrike" dirty="0"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xmlns="" val="32676866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4638544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3" b="13035"/>
          <a:stretch/>
        </p:blipFill>
        <p:spPr>
          <a:xfrm>
            <a:off x="4720176" y="1096778"/>
            <a:ext cx="3832567" cy="2684201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4" b="12726"/>
          <a:stretch/>
        </p:blipFill>
        <p:spPr>
          <a:xfrm>
            <a:off x="524593" y="1128751"/>
            <a:ext cx="3815359" cy="26937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90543" y="172478"/>
            <a:ext cx="9376079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GB" sz="1200" b="1" smtClean="0"/>
              <a:t>Figure S</a:t>
            </a:r>
            <a:r>
              <a:rPr lang="en-US" sz="1200" b="1" smtClean="0"/>
              <a:t>3</a:t>
            </a:r>
            <a:r>
              <a:rPr lang="en-US" sz="1200" b="1" dirty="0"/>
              <a:t>. </a:t>
            </a:r>
            <a:r>
              <a:rPr lang="en-US" sz="1200" dirty="0"/>
              <a:t>Scatterplots of ER </a:t>
            </a:r>
            <a:r>
              <a:rPr lang="en-US" sz="1200" dirty="0" err="1"/>
              <a:t>rtPCR</a:t>
            </a:r>
            <a:r>
              <a:rPr lang="en-US" sz="1200" dirty="0"/>
              <a:t> relative expression in relation to Ki67 in </a:t>
            </a:r>
            <a:r>
              <a:rPr lang="en-US" sz="1200" dirty="0" err="1"/>
              <a:t>PgR</a:t>
            </a:r>
            <a:r>
              <a:rPr lang="en-US" sz="1200" dirty="0"/>
              <a:t>- (A) and </a:t>
            </a:r>
            <a:r>
              <a:rPr lang="en-US" sz="1200" dirty="0" err="1"/>
              <a:t>PgR</a:t>
            </a:r>
            <a:r>
              <a:rPr lang="en-US" sz="1200" dirty="0"/>
              <a:t> + (B) using 10% as a threshold for positivity.</a:t>
            </a:r>
            <a:endParaRPr lang="en-GB" sz="1200" dirty="0"/>
          </a:p>
          <a:p>
            <a:endParaRPr lang="en-GB" sz="1200" b="1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-36881" y="2367891"/>
            <a:ext cx="83708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% Ki67 Residua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73136" y="4019069"/>
            <a:ext cx="13420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ER qPCR relative expressio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986961" y="4019069"/>
            <a:ext cx="13420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ER qPCR relative expression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18585" y="3797735"/>
            <a:ext cx="365657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0.1	                1	                              10	                        100                             1000</a:t>
            </a:r>
            <a:endParaRPr lang="en-GB" sz="800" dirty="0"/>
          </a:p>
        </p:txBody>
      </p:sp>
      <p:sp>
        <p:nvSpPr>
          <p:cNvPr id="12" name="TextBox 11"/>
          <p:cNvSpPr txBox="1"/>
          <p:nvPr/>
        </p:nvSpPr>
        <p:spPr>
          <a:xfrm>
            <a:off x="4929776" y="3797735"/>
            <a:ext cx="377607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/>
              <a:t>0.1	                 1	                              10	                         100                          1000</a:t>
            </a:r>
            <a:endParaRPr lang="en-GB" sz="800" dirty="0"/>
          </a:p>
        </p:txBody>
      </p:sp>
      <p:sp>
        <p:nvSpPr>
          <p:cNvPr id="13" name="TextBox 12"/>
          <p:cNvSpPr txBox="1"/>
          <p:nvPr/>
        </p:nvSpPr>
        <p:spPr>
          <a:xfrm>
            <a:off x="454179" y="958280"/>
            <a:ext cx="6442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A. </a:t>
            </a:r>
            <a:r>
              <a:rPr lang="en-GB" sz="1200" b="1" dirty="0" err="1"/>
              <a:t>PgR</a:t>
            </a:r>
            <a:r>
              <a:rPr lang="en-GB" sz="1200" b="1" dirty="0"/>
              <a:t>-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720176" y="958280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B. </a:t>
            </a:r>
            <a:r>
              <a:rPr lang="en-GB" sz="1200" b="1" dirty="0" err="1"/>
              <a:t>PgR</a:t>
            </a:r>
            <a:r>
              <a:rPr lang="en-GB" sz="1200" b="1" dirty="0"/>
              <a:t>+</a:t>
            </a:r>
          </a:p>
        </p:txBody>
      </p:sp>
      <p:sp>
        <p:nvSpPr>
          <p:cNvPr id="15" name="TextBox 14"/>
          <p:cNvSpPr txBox="1"/>
          <p:nvPr/>
        </p:nvSpPr>
        <p:spPr>
          <a:xfrm rot="16200000">
            <a:off x="-615652" y="2512727"/>
            <a:ext cx="235688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/>
              <a:t>1%	        10%	                  100%	 </a:t>
            </a:r>
          </a:p>
        </p:txBody>
      </p:sp>
      <p:sp>
        <p:nvSpPr>
          <p:cNvPr id="16" name="TextBox 15"/>
          <p:cNvSpPr txBox="1"/>
          <p:nvPr/>
        </p:nvSpPr>
        <p:spPr>
          <a:xfrm rot="16200000">
            <a:off x="3592417" y="2494814"/>
            <a:ext cx="235688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/>
              <a:t>1%	        10%	                  100%	 </a:t>
            </a:r>
          </a:p>
        </p:txBody>
      </p:sp>
    </p:spTree>
    <p:extLst>
      <p:ext uri="{BB962C8B-B14F-4D97-AF65-F5344CB8AC3E}">
        <p14:creationId xmlns:p14="http://schemas.microsoft.com/office/powerpoint/2010/main" val="1206356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28</TotalTime>
  <Words>2688</Words>
  <Application>Microsoft Office PowerPoint</Application>
  <PresentationFormat>A4 Paper (210x297 mm)</PresentationFormat>
  <Paragraphs>1445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nstitute of Cancer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lena Lopez Knowles</dc:creator>
  <cp:lastModifiedBy>Bhuvaneswari A.</cp:lastModifiedBy>
  <cp:revision>430</cp:revision>
  <cp:lastPrinted>2021-09-14T08:14:49Z</cp:lastPrinted>
  <dcterms:created xsi:type="dcterms:W3CDTF">2021-06-01T13:26:59Z</dcterms:created>
  <dcterms:modified xsi:type="dcterms:W3CDTF">2022-09-03T11:23:22Z</dcterms:modified>
</cp:coreProperties>
</file>